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6433" autoAdjust="0"/>
  </p:normalViewPr>
  <p:slideViewPr>
    <p:cSldViewPr snapToGrid="0">
      <p:cViewPr varScale="1">
        <p:scale>
          <a:sx n="115" d="100"/>
          <a:sy n="115" d="100"/>
        </p:scale>
        <p:origin x="-96" y="-19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1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892661-7AF5-44E5-AF65-4FC164862E9F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4F7690-8410-4FC5-B7E2-7F823410D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660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920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283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664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786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494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974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472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581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944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313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964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94654-0A62-4903-8BE4-2793DB9E532B}" type="datetimeFigureOut">
              <a:rPr lang="en-US" smtClean="0"/>
              <a:t>12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C3996-FED4-4DD2-89F4-AE8227CFA9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446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15142" y="5654180"/>
            <a:ext cx="9697599" cy="1077459"/>
          </a:xfrm>
        </p:spPr>
        <p:txBody>
          <a:bodyPr>
            <a:normAutofit/>
          </a:bodyPr>
          <a:lstStyle/>
          <a:p>
            <a:pPr algn="l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Selected gene fragments cDNA synthesis (A) and ligation in pET28a (B) and pGS-21a 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Genes include; TpMuguga_04g00437(p104), TpMuguga_01g00939 (p34), TpMuguga_03g00136 (136), TpMuguga_01g00095 (095), TpMuguga_01g00972 (972), TpMuguga_01g00876 (876), TpMuguga_04g02375/TP04_0030 (030), TpMuguga_01g00575 (575), TpMuguga_02g00792 (792) and TpMuguga_03g00844 (844). Genes in pET28a (B) and pGS-21a (C) loaded as non-digested and BamHI/NotI digested . Sizes of fragments are shown in brackets.</a:t>
            </a:r>
          </a:p>
          <a:p>
            <a:pPr algn="l"/>
            <a:endParaRPr lang="en-US" sz="1200" dirty="0"/>
          </a:p>
          <a:p>
            <a:pPr algn="l"/>
            <a:endParaRPr lang="en-US" sz="1200" dirty="0"/>
          </a:p>
          <a:p>
            <a:pPr algn="l"/>
            <a:endParaRPr lang="en-US" sz="1200" dirty="0"/>
          </a:p>
          <a:p>
            <a:pPr algn="l"/>
            <a:endParaRPr lang="en-US" sz="1200" dirty="0"/>
          </a:p>
          <a:p>
            <a:pPr algn="l"/>
            <a:endParaRPr lang="en-US" sz="1200" dirty="0"/>
          </a:p>
          <a:p>
            <a:pPr algn="l"/>
            <a:endParaRPr lang="en-US" sz="1200" dirty="0"/>
          </a:p>
          <a:p>
            <a:pPr algn="l"/>
            <a:endParaRPr lang="en-US" sz="1200" dirty="0"/>
          </a:p>
          <a:p>
            <a:pPr algn="l"/>
            <a:endParaRPr lang="en-US" sz="1200" dirty="0"/>
          </a:p>
          <a:p>
            <a:pPr algn="l"/>
            <a:endParaRPr lang="en-US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1919415" y="1901682"/>
            <a:ext cx="1054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030 (296bp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359220" y="1793960"/>
            <a:ext cx="1054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095 (331bp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049281" y="1857636"/>
            <a:ext cx="1054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p104 (312bp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9457037" y="1609862"/>
            <a:ext cx="1054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972 (320bp)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8769429" y="1684003"/>
            <a:ext cx="1054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792 (281bp)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8179647" y="1684003"/>
            <a:ext cx="10544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</a:rPr>
              <a:t>844 (330bp)</a:t>
            </a: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2"/>
          <a:srcRect l="39362" t="3883" r="2325" b="18834"/>
          <a:stretch/>
        </p:blipFill>
        <p:spPr>
          <a:xfrm>
            <a:off x="5103725" y="385894"/>
            <a:ext cx="6538084" cy="487400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E41A7E0E-03CD-4811-9130-9CD21E4D02C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1" t="3883" r="61148" b="60741"/>
          <a:stretch/>
        </p:blipFill>
        <p:spPr>
          <a:xfrm>
            <a:off x="808224" y="1717584"/>
            <a:ext cx="4331270" cy="2231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4964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87</TotalTime>
  <Words>138</Words>
  <Application>Microsoft Macintosh PowerPoint</Application>
  <PresentationFormat>Custom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Passang Sherpa</cp:lastModifiedBy>
  <cp:revision>1</cp:revision>
  <cp:lastPrinted>2017-10-11T21:08:04Z</cp:lastPrinted>
  <dcterms:modified xsi:type="dcterms:W3CDTF">2018-03-12T05:31:06Z</dcterms:modified>
</cp:coreProperties>
</file>